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887"/>
    <p:restoredTop sz="94693"/>
  </p:normalViewPr>
  <p:slideViewPr>
    <p:cSldViewPr snapToGrid="0">
      <p:cViewPr varScale="1">
        <p:scale>
          <a:sx n="116" d="100"/>
          <a:sy n="116" d="100"/>
        </p:scale>
        <p:origin x="208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E9DE49D-C257-8487-BCD7-45C9831AD74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1518669-A706-0313-5594-9EF9D08299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2353C24-1172-89C2-931A-616D0DC53D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74E18-2605-4C53-AEFA-8A2721CFC717}" type="datetimeFigureOut">
              <a:rPr lang="zh-CN" altLang="en-US" smtClean="0"/>
              <a:t>2023/5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F8AAED7-3ECC-37EB-9CE1-56FDF5B8EF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08AF176-B03D-328C-BBC3-E6B7515197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BAB94-4776-4B5C-9F63-07CD73F3E8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25071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F32C4F8-FFCF-F44B-02FF-4CCB7E6966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553EF5C-4646-68EB-646C-2A4F6E7C3F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7D68334-7FAC-794C-F672-5ADDF2ECFD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74E18-2605-4C53-AEFA-8A2721CFC717}" type="datetimeFigureOut">
              <a:rPr lang="zh-CN" altLang="en-US" smtClean="0"/>
              <a:t>2023/5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34781D1-E794-6BC9-238F-8B05FD7A85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1502641-C979-25F9-2895-442C457194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BAB94-4776-4B5C-9F63-07CD73F3E8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8629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0083486-B810-B3D3-ABBF-40B44A86AA9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D8A32BA-7E2C-C278-38D6-0CD118246F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259BD56-AA88-9BB3-6EC0-5765ECC6BF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74E18-2605-4C53-AEFA-8A2721CFC717}" type="datetimeFigureOut">
              <a:rPr lang="zh-CN" altLang="en-US" smtClean="0"/>
              <a:t>2023/5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B0A88C2-7D01-5569-78D0-7E01A3826B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A816838-A577-7AD9-E953-CE293AC2F4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BAB94-4776-4B5C-9F63-07CD73F3E8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50069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D3FC1BA-28DA-6170-135C-718A941D62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BE60CFC-25D7-188D-D26C-E9E99A466E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4951E1E-DAEC-25F1-3E02-EBD22A7701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74E18-2605-4C53-AEFA-8A2721CFC717}" type="datetimeFigureOut">
              <a:rPr lang="zh-CN" altLang="en-US" smtClean="0"/>
              <a:t>2023/5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F55CE9-32DD-A818-57AC-113605C11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7CC4182-6641-B205-EE91-3A69BA50D3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BAB94-4776-4B5C-9F63-07CD73F3E8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24248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83FB760-8100-34CF-6237-05E524BA58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AB88461-F78C-D91F-BAC1-E9E95B09F4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1FC2EA2-9328-2F2C-B0F0-096B47FFCA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74E18-2605-4C53-AEFA-8A2721CFC717}" type="datetimeFigureOut">
              <a:rPr lang="zh-CN" altLang="en-US" smtClean="0"/>
              <a:t>2023/5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75C5D5F-36B1-115B-388F-FFF686EEAA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0D9580C-2CEF-1D9A-FEC4-BDE882AEE9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BAB94-4776-4B5C-9F63-07CD73F3E8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36953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56EB793-A880-A603-2EE3-E4B100F21D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001A818-5D25-9619-A52F-CC9AFAC98A6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39D1F2A-CE28-0262-1397-C3C5F73B16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90E4661-B0D9-0043-0297-F83A5F5CED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74E18-2605-4C53-AEFA-8A2721CFC717}" type="datetimeFigureOut">
              <a:rPr lang="zh-CN" altLang="en-US" smtClean="0"/>
              <a:t>2023/5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EBDE8AF-3ED5-F6E1-DB3B-809F14EB5B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58D4647-4931-68DD-B91D-671D22A163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BAB94-4776-4B5C-9F63-07CD73F3E8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4525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AD81881-BB31-2A11-27C9-96A6C43FE4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E483592-909D-4211-2EAD-A0172B725E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3CBE8BA-7004-B4E1-9CBE-8BFCED993C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990D4C3-8D9C-4F5F-187A-74F6485075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D6E0143-440C-5637-001D-08A65DA3A88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6B4F270-817C-668D-828A-4D8833AE6E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74E18-2605-4C53-AEFA-8A2721CFC717}" type="datetimeFigureOut">
              <a:rPr lang="zh-CN" altLang="en-US" smtClean="0"/>
              <a:t>2023/5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81CF9C6-31E8-98D1-5164-9962CE8A08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C159A7D-ED93-E5D4-883C-F170B6BD9A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BAB94-4776-4B5C-9F63-07CD73F3E8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80818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E570E85-FD33-8C1D-27CA-1EA28AB09B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F86AFDE-CDF6-F3F6-4F7A-84722240A6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74E18-2605-4C53-AEFA-8A2721CFC717}" type="datetimeFigureOut">
              <a:rPr lang="zh-CN" altLang="en-US" smtClean="0"/>
              <a:t>2023/5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E4A4AE3-BE49-A520-5F1A-B00A3876AE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6BC5804-A8A9-CB30-8B01-A9B79B0623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BAB94-4776-4B5C-9F63-07CD73F3E8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65774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436EA11-1601-D829-D9BF-DF10D1CF7A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74E18-2605-4C53-AEFA-8A2721CFC717}" type="datetimeFigureOut">
              <a:rPr lang="zh-CN" altLang="en-US" smtClean="0"/>
              <a:t>2023/5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4DA8148-99E7-EF25-9E47-A60940D75C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E2928D7-FC68-8B22-31E2-794BAA079D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BAB94-4776-4B5C-9F63-07CD73F3E8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78645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B1BA02E-43EE-1EFF-2D33-25C92B5229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B7706C6-CCAC-8421-A349-EE51DD00CBF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07FB108-D5A4-AF95-E6DA-8AA1E45CD8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76E4078-474C-64CD-2A9C-66FFB4B212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74E18-2605-4C53-AEFA-8A2721CFC717}" type="datetimeFigureOut">
              <a:rPr lang="zh-CN" altLang="en-US" smtClean="0"/>
              <a:t>2023/5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243ADCC-5066-50BD-98FF-4AC680FD30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9EC6EF6-56EC-D90E-277A-71377EAF6C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BAB94-4776-4B5C-9F63-07CD73F3E8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6740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EFC0772-AD53-BECF-75D1-40E1DA0ED7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044B92B-4EFC-95B7-C8C9-3960FD29E72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2E3ADFD-7E7B-6F58-7BB6-5993C2B171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327BA13-8559-3383-5A23-853A4BF8C2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74E18-2605-4C53-AEFA-8A2721CFC717}" type="datetimeFigureOut">
              <a:rPr lang="zh-CN" altLang="en-US" smtClean="0"/>
              <a:t>2023/5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8B6B15A-C9A6-EC40-2533-AE7DADDF14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5E81C4A-E748-6E0B-6312-20B9EB456B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BAB94-4776-4B5C-9F63-07CD73F3E8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59201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0E9A0F8-7A10-BCC8-C9EA-C7E6DED818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4975E2F-F233-18FB-16E4-0062DD3E38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47C9CC9-6282-C45C-A87B-DC6EEA96FB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C74E18-2605-4C53-AEFA-8A2721CFC717}" type="datetimeFigureOut">
              <a:rPr lang="zh-CN" altLang="en-US" smtClean="0"/>
              <a:t>2023/5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D215E39-91E0-E2B4-FDC1-ADE9BCA103B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D672DD3-441E-F604-4228-1720367958D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BBAB94-4776-4B5C-9F63-07CD73F3E8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31268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6BADF02-D2BD-E5D5-2C4A-5205850D3AC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47620" y="1147494"/>
            <a:ext cx="11096760" cy="4563011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43421B86-E136-79C3-C923-EA343C8306BF}"/>
              </a:ext>
            </a:extLst>
          </p:cNvPr>
          <p:cNvSpPr txBox="1"/>
          <p:nvPr/>
        </p:nvSpPr>
        <p:spPr>
          <a:xfrm>
            <a:off x="0" y="6119336"/>
            <a:ext cx="12192000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1. Study flowchart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HC, immunohistochemistry;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TIL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stromal tumor infiltrating lymphocyte; HER2, human epidermal growth factor receptor 2;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R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pathologic complete response; NAC, neo-adjuvant chemotherapy; FFPE, formalin fixed paraffin-embedded. 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02902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4328E48-1E45-1AA0-DF32-A0A4CE25326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663216" y="265355"/>
            <a:ext cx="8865567" cy="5718514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19C4C050-09A0-5E73-3C92-BEA74490417E}"/>
              </a:ext>
            </a:extLst>
          </p:cNvPr>
          <p:cNvSpPr txBox="1"/>
          <p:nvPr/>
        </p:nvSpPr>
        <p:spPr>
          <a:xfrm>
            <a:off x="0" y="6125170"/>
            <a:ext cx="12192000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2. Univariable and multivariable analysis of factors associated with </a:t>
            </a:r>
            <a:r>
              <a:rPr lang="en-US" altLang="zh-CN" sz="14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TILs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in all 	patients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bbreviations: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TIL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en-US" altLang="zh-CN" sz="14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tromal tumor-infiltrating lymphocyte; Pre/peri, Pre/perimenopausal; Post, postmenopausal; CCI,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harlson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omorbidity Index; IDC, invasive ductal carcinoma; ER, estrogen receptor; PR, progestogen receptor; LVI, lymph vascular invasion; HER2, human epidermal growth factor receptor 2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70536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558522D3-6A33-B712-EB48-CF72660EEED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370157" y="675513"/>
            <a:ext cx="9451685" cy="5506973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798AB90D-CADE-A2AC-45A0-3A558B48B2A8}"/>
              </a:ext>
            </a:extLst>
          </p:cNvPr>
          <p:cNvSpPr txBox="1"/>
          <p:nvPr/>
        </p:nvSpPr>
        <p:spPr>
          <a:xfrm>
            <a:off x="0" y="6125170"/>
            <a:ext cx="12192000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kern="10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3. 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rognostic value of HER2 status on overall survival in (A) all, (B) ER-positive, (C) ER-negative, (D) </a:t>
            </a:r>
            <a:r>
              <a:rPr lang="en-US" altLang="zh-CN" sz="14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TILs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low, (E) </a:t>
            </a:r>
            <a:r>
              <a:rPr lang="en-US" altLang="zh-CN" sz="14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TILs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intermediate, and (F) </a:t>
            </a:r>
            <a:r>
              <a:rPr lang="en-US" altLang="zh-CN" sz="14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TILs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high population.</a:t>
            </a:r>
          </a:p>
          <a:p>
            <a:pPr algn="just"/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bbreviations: HER2, human epidermal growth factor receptor 2; ER, estrogen receptor;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TIL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stromal tumor-infiltrating lymphocyte. </a:t>
            </a:r>
          </a:p>
        </p:txBody>
      </p:sp>
    </p:spTree>
    <p:extLst>
      <p:ext uri="{BB962C8B-B14F-4D97-AF65-F5344CB8AC3E}">
        <p14:creationId xmlns:p14="http://schemas.microsoft.com/office/powerpoint/2010/main" val="39751849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281D52C-D346-0121-C89D-0555458F1BA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388365" y="662858"/>
            <a:ext cx="9415270" cy="5532283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6A806394-4053-5C07-8884-559F2EE44969}"/>
              </a:ext>
            </a:extLst>
          </p:cNvPr>
          <p:cNvSpPr txBox="1"/>
          <p:nvPr/>
        </p:nvSpPr>
        <p:spPr>
          <a:xfrm>
            <a:off x="0" y="6325195"/>
            <a:ext cx="12192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4. Influence of </a:t>
            </a:r>
            <a:r>
              <a:rPr lang="en-US" altLang="zh-CN" sz="14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TILs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on recurrence-free survival (A-C) and overall survival (D-F) in HER2-Low population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bbreviations: HER2, human epidermal growth factor receptor 2; ER, estrogen receptor;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TIL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stromal tumor-infiltrating lymphocytes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35139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281D52C-D346-0121-C89D-0555458F1BA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765340" y="662858"/>
            <a:ext cx="6661320" cy="5532283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6A806394-4053-5C07-8884-559F2EE44969}"/>
              </a:ext>
            </a:extLst>
          </p:cNvPr>
          <p:cNvSpPr txBox="1"/>
          <p:nvPr/>
        </p:nvSpPr>
        <p:spPr>
          <a:xfrm>
            <a:off x="0" y="6325195"/>
            <a:ext cx="12192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S5. </a:t>
            </a:r>
            <a:r>
              <a:rPr lang="en-US" altLang="zh-CN" sz="1400" b="1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TILs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distribution before and after NAC. Thirty patients achieved </a:t>
            </a:r>
            <a:r>
              <a:rPr lang="en-US" altLang="zh-CN" sz="1400" b="1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CR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after NAC.</a:t>
            </a:r>
            <a:endParaRPr lang="zh-CN" altLang="zh-CN" sz="14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4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bbreviations: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TIL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stromal tumor-infiltrating lymphocytes; NAC, neoadjuvant chemotherapy;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CR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pathological complete response.</a:t>
            </a:r>
            <a:endParaRPr lang="zh-CN" altLang="zh-CN" sz="14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31504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266</Words>
  <Application>Microsoft Macintosh PowerPoint</Application>
  <PresentationFormat>宽屏</PresentationFormat>
  <Paragraphs>10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1" baseType="lpstr">
      <vt:lpstr>DengXian</vt:lpstr>
      <vt:lpstr>DengXian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裕杰 陆</dc:creator>
  <cp:lastModifiedBy>Yujie Lu</cp:lastModifiedBy>
  <cp:revision>5</cp:revision>
  <dcterms:created xsi:type="dcterms:W3CDTF">2022-08-04T14:08:30Z</dcterms:created>
  <dcterms:modified xsi:type="dcterms:W3CDTF">2023-05-15T09:52:19Z</dcterms:modified>
</cp:coreProperties>
</file>